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993" autoAdjust="0"/>
    <p:restoredTop sz="94660"/>
  </p:normalViewPr>
  <p:slideViewPr>
    <p:cSldViewPr snapToGrid="0">
      <p:cViewPr varScale="1">
        <p:scale>
          <a:sx n="153" d="100"/>
          <a:sy n="153" d="100"/>
        </p:scale>
        <p:origin x="468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1B536A2-F6D6-1C29-9C2A-0833A5FC396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0612DFF5-1260-F683-79BA-92A59621802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151A9D8F-CE99-628F-8CDE-0818475A85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33298-CBE4-486F-91AE-846E9260C853}" type="datetimeFigureOut">
              <a:rPr lang="ko-KR" altLang="en-US" smtClean="0"/>
              <a:t>2025-05-0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F00B5AF-BC3A-3E5C-657C-09367E294E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5045769-40CF-094B-AE12-E11288E974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464752-A1D5-4F27-89B5-2B0A9C71FF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733318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128476D-1943-9C45-D2FC-E2354A8B4C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7A562E67-1D7B-2C78-C182-AD4395A9EFA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04815F6-0035-E246-7DDC-0285DF1B91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33298-CBE4-486F-91AE-846E9260C853}" type="datetimeFigureOut">
              <a:rPr lang="ko-KR" altLang="en-US" smtClean="0"/>
              <a:t>2025-05-0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297BDF7-62E5-1723-9D90-9E5B213A25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BDA28F56-7E6E-D8D2-6811-A00467FC47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464752-A1D5-4F27-89B5-2B0A9C71FF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251938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E98A41D6-4C7B-C945-F184-8F142FF4897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E8DE8051-8A6D-9BA4-8226-BAB5616C2C2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1C7ECC5C-6BCD-857F-1CAA-BFB684C74B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33298-CBE4-486F-91AE-846E9260C853}" type="datetimeFigureOut">
              <a:rPr lang="ko-KR" altLang="en-US" smtClean="0"/>
              <a:t>2025-05-0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CA509700-4501-A6D3-E034-705DAEC100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CDE5A1D-A2D1-0483-1AD8-95306268E4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464752-A1D5-4F27-89B5-2B0A9C71FF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85709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6CD8059-5D9F-C090-DC16-98EBE11E8C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A705F9FC-2B21-B351-60C4-38B261820A3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B461B82-6355-6671-7EE6-FB9F85F2B4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33298-CBE4-486F-91AE-846E9260C853}" type="datetimeFigureOut">
              <a:rPr lang="ko-KR" altLang="en-US" smtClean="0"/>
              <a:t>2025-05-0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1FADE5D-8D0D-CC32-5C3C-E294CF5623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C8767CB-685B-AE70-B87D-893EB8B6EE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464752-A1D5-4F27-89B5-2B0A9C71FF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267434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3EF7701-2E04-1DD9-A0C3-FC24F2520F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272F439A-5CBF-8CC1-FB1E-0956DD1667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17AE30C-10E9-F1EB-DB2A-9684947069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33298-CBE4-486F-91AE-846E9260C853}" type="datetimeFigureOut">
              <a:rPr lang="ko-KR" altLang="en-US" smtClean="0"/>
              <a:t>2025-05-0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C7C045A8-F559-0E7F-2CD3-9DE76C470F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96D26EB-50EE-D61B-973A-DDCE223980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464752-A1D5-4F27-89B5-2B0A9C71FF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439757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AB28D03-D8DE-72F6-12DE-4CED36FBE0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A0491FC5-D3E3-13E2-5F15-3B836B8FB26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620103F0-B0BC-62E0-BD2E-F58E75F4828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AF5EE837-A155-EF77-13D9-A55C17AFC0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33298-CBE4-486F-91AE-846E9260C853}" type="datetimeFigureOut">
              <a:rPr lang="ko-KR" altLang="en-US" smtClean="0"/>
              <a:t>2025-05-05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481137BB-5517-94E3-46B5-AC1766FD1B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AC42C242-C1C6-0219-4A51-03290314BF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464752-A1D5-4F27-89B5-2B0A9C71FF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149759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A823AAF-4B31-2E8E-7AD0-6767DF5C43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782AEC3E-C0A0-FB3F-5D5D-0F71828D14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A3EE30E4-30A4-5525-DFD3-635122EDCFC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4211F0DB-6124-FC40-E9DB-DDBDECA7B80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927D4CBE-0F68-2616-7CB7-557B4CEAF42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6AC1DEED-191E-E405-4504-7A0D64664C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33298-CBE4-486F-91AE-846E9260C853}" type="datetimeFigureOut">
              <a:rPr lang="ko-KR" altLang="en-US" smtClean="0"/>
              <a:t>2025-05-05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4D0D245E-4A24-51E6-5B5E-01CEF7E972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45D836F8-ED6F-6D6A-D622-97347E0348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464752-A1D5-4F27-89B5-2B0A9C71FF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180421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57324E2-DC4B-A84B-A6F0-52C71B53EC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ED0D6BA2-3C7B-3D40-3655-5683532667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33298-CBE4-486F-91AE-846E9260C853}" type="datetimeFigureOut">
              <a:rPr lang="ko-KR" altLang="en-US" smtClean="0"/>
              <a:t>2025-05-05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093E3B7B-025A-7B2D-40F5-57B92CA3BE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49D06F21-BE7E-9D70-55D6-94C6D62C40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464752-A1D5-4F27-89B5-2B0A9C71FF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25550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52002CBF-0B45-AD99-39E8-1D80BF60BF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33298-CBE4-486F-91AE-846E9260C853}" type="datetimeFigureOut">
              <a:rPr lang="ko-KR" altLang="en-US" smtClean="0"/>
              <a:t>2025-05-05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E2E7F42A-408F-1E9C-31C4-8C3331B4AA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EBD348F9-C25F-BE5A-969D-2CD1A3CDBB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464752-A1D5-4F27-89B5-2B0A9C71FF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930846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4A1D35C-43AE-ABE1-23FA-4E88F924D6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066373FA-8F5A-A635-186F-5CE21FB4F3D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392B0F6E-D7BC-EEAC-CA35-9ED21D421A8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8BBBF9BB-2C9A-C4C9-E99C-65EF8F99A1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33298-CBE4-486F-91AE-846E9260C853}" type="datetimeFigureOut">
              <a:rPr lang="ko-KR" altLang="en-US" smtClean="0"/>
              <a:t>2025-05-05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987B312B-7C29-0CD7-29B3-01AE3943AE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FA72A9F8-285D-971E-8045-960402A2BD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464752-A1D5-4F27-89B5-2B0A9C71FF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700965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81B775F-2C27-0867-E03E-9C72A37023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CEE82FA8-1A21-3F38-53B4-3449FFE63BC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B589FC59-DE9F-A2F3-7E12-5C165114BD7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79319D16-1E90-10F7-A4E1-031F5BE445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33298-CBE4-486F-91AE-846E9260C853}" type="datetimeFigureOut">
              <a:rPr lang="ko-KR" altLang="en-US" smtClean="0"/>
              <a:t>2025-05-05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4D1DF3F2-0C0C-CF4D-0504-501E4236FC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BD3BCC8B-8B47-48D9-D5DF-6A0BD6C298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464752-A1D5-4F27-89B5-2B0A9C71FF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62172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90976329-6839-FA33-5432-CE98FD8188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786DAE81-0D4A-7CD5-D441-BE3A1B0095C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F2EE1FB-A6DE-EA4F-D22D-8B098771934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A33298-CBE4-486F-91AE-846E9260C853}" type="datetimeFigureOut">
              <a:rPr lang="ko-KR" altLang="en-US" smtClean="0"/>
              <a:t>2025-05-0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E6F5445-CA11-2A03-9A59-6E3EDE748B0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BAE0BB9-DF6C-F32F-3BFC-4CA760855EB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464752-A1D5-4F27-89B5-2B0A9C71FF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019053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>
            <a:extLst>
              <a:ext uri="{FF2B5EF4-FFF2-40B4-BE49-F238E27FC236}">
                <a16:creationId xmlns:a16="http://schemas.microsoft.com/office/drawing/2014/main" id="{0AEDBFE0-87C5-346B-077F-0F6F8ABBAD49}"/>
              </a:ext>
            </a:extLst>
          </p:cNvPr>
          <p:cNvGrpSpPr/>
          <p:nvPr/>
        </p:nvGrpSpPr>
        <p:grpSpPr>
          <a:xfrm>
            <a:off x="4721833" y="1552621"/>
            <a:ext cx="5277778" cy="4445190"/>
            <a:chOff x="685425" y="358458"/>
            <a:chExt cx="6140475" cy="5161283"/>
          </a:xfrm>
        </p:grpSpPr>
        <p:pic>
          <p:nvPicPr>
            <p:cNvPr id="5" name="그림 4" descr="텍스트, 바둑판식이(가) 표시된 사진&#10;&#10;자동 생성된 설명">
              <a:extLst>
                <a:ext uri="{FF2B5EF4-FFF2-40B4-BE49-F238E27FC236}">
                  <a16:creationId xmlns:a16="http://schemas.microsoft.com/office/drawing/2014/main" id="{F8970119-5B2C-932C-71BF-9359C92BF21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5425" y="358458"/>
              <a:ext cx="2950403" cy="2384741"/>
            </a:xfrm>
            <a:prstGeom prst="rect">
              <a:avLst/>
            </a:prstGeom>
          </p:spPr>
        </p:pic>
        <p:pic>
          <p:nvPicPr>
            <p:cNvPr id="6" name="그림 5" descr="텍스트, 바둑판식이(가) 표시된 사진&#10;&#10;자동 생성된 설명">
              <a:extLst>
                <a:ext uri="{FF2B5EF4-FFF2-40B4-BE49-F238E27FC236}">
                  <a16:creationId xmlns:a16="http://schemas.microsoft.com/office/drawing/2014/main" id="{6CD4B0C0-3370-4424-8E6D-BE5FA8CF5A2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73283" y="3065585"/>
              <a:ext cx="2852617" cy="2454156"/>
            </a:xfrm>
            <a:prstGeom prst="rect">
              <a:avLst/>
            </a:prstGeom>
          </p:spPr>
        </p:pic>
        <p:pic>
          <p:nvPicPr>
            <p:cNvPr id="7" name="그림 6">
              <a:extLst>
                <a:ext uri="{FF2B5EF4-FFF2-40B4-BE49-F238E27FC236}">
                  <a16:creationId xmlns:a16="http://schemas.microsoft.com/office/drawing/2014/main" id="{A0FA9041-DEFA-CA76-1DB5-C0C72FA8C6C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73283" y="364331"/>
              <a:ext cx="2852617" cy="2372994"/>
            </a:xfrm>
            <a:prstGeom prst="rect">
              <a:avLst/>
            </a:prstGeom>
          </p:spPr>
        </p:pic>
        <p:pic>
          <p:nvPicPr>
            <p:cNvPr id="8" name="그림 7">
              <a:extLst>
                <a:ext uri="{FF2B5EF4-FFF2-40B4-BE49-F238E27FC236}">
                  <a16:creationId xmlns:a16="http://schemas.microsoft.com/office/drawing/2014/main" id="{276D3811-2ABB-B3C3-2038-9EEB78A0042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5425" y="3125384"/>
              <a:ext cx="3004769" cy="2384740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3CB5C4E5-D26C-1884-0956-754A92C61084}"/>
                </a:ext>
              </a:extLst>
            </p:cNvPr>
            <p:cNvSpPr txBox="1"/>
            <p:nvPr/>
          </p:nvSpPr>
          <p:spPr>
            <a:xfrm>
              <a:off x="1939183" y="1070877"/>
              <a:ext cx="49725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 cm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FDC16461-C4B3-11A6-A798-6F3EF4DD55B3}"/>
                </a:ext>
              </a:extLst>
            </p:cNvPr>
            <p:cNvSpPr txBox="1"/>
            <p:nvPr/>
          </p:nvSpPr>
          <p:spPr>
            <a:xfrm>
              <a:off x="1681740" y="3854191"/>
              <a:ext cx="51488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b="1" dirty="0"/>
                <a:t>3 cm</a:t>
              </a:r>
              <a:endParaRPr lang="ko-KR" altLang="en-US" sz="1100" b="1" dirty="0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EAE10508-AB50-4710-EFBE-ABEFB9619341}"/>
                </a:ext>
              </a:extLst>
            </p:cNvPr>
            <p:cNvSpPr txBox="1"/>
            <p:nvPr/>
          </p:nvSpPr>
          <p:spPr>
            <a:xfrm>
              <a:off x="4792794" y="1046953"/>
              <a:ext cx="51488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50" b="1" dirty="0"/>
                <a:t>4 cm</a:t>
              </a:r>
              <a:endParaRPr lang="ko-KR" altLang="en-US" sz="1050" b="1" dirty="0"/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1F19DBE4-3551-2B88-7943-034147A0F6DF}"/>
                </a:ext>
              </a:extLst>
            </p:cNvPr>
            <p:cNvSpPr txBox="1"/>
            <p:nvPr/>
          </p:nvSpPr>
          <p:spPr>
            <a:xfrm>
              <a:off x="5034207" y="3577193"/>
              <a:ext cx="54694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/>
                <a:t>5 cm</a:t>
              </a:r>
              <a:endParaRPr lang="ko-KR" altLang="en-US" sz="1200" b="1" dirty="0"/>
            </a:p>
          </p:txBody>
        </p:sp>
      </p:grpSp>
      <p:pic>
        <p:nvPicPr>
          <p:cNvPr id="13" name="그림 12" descr="실내, 벽이(가) 표시된 사진&#10;&#10;자동 생성된 설명">
            <a:extLst>
              <a:ext uri="{FF2B5EF4-FFF2-40B4-BE49-F238E27FC236}">
                <a16:creationId xmlns:a16="http://schemas.microsoft.com/office/drawing/2014/main" id="{1751E4C1-CFD3-643E-4280-220EDAB6694B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64623" y="1526280"/>
            <a:ext cx="1334924" cy="2533511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8441A9B3-B858-5516-84C5-73F6EED6F26C}"/>
              </a:ext>
            </a:extLst>
          </p:cNvPr>
          <p:cNvSpPr txBox="1"/>
          <p:nvPr/>
        </p:nvSpPr>
        <p:spPr>
          <a:xfrm>
            <a:off x="1564622" y="4074729"/>
            <a:ext cx="13083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6cm applicator </a:t>
            </a:r>
            <a:endParaRPr lang="ko-KR" altLang="en-US" sz="1400" dirty="0"/>
          </a:p>
        </p:txBody>
      </p:sp>
      <p:sp>
        <p:nvSpPr>
          <p:cNvPr id="15" name="더하기 기호 14">
            <a:extLst>
              <a:ext uri="{FF2B5EF4-FFF2-40B4-BE49-F238E27FC236}">
                <a16:creationId xmlns:a16="http://schemas.microsoft.com/office/drawing/2014/main" id="{C82649AA-5CE5-16CD-688B-FE4423AA28C2}"/>
              </a:ext>
            </a:extLst>
          </p:cNvPr>
          <p:cNvSpPr/>
          <p:nvPr/>
        </p:nvSpPr>
        <p:spPr>
          <a:xfrm>
            <a:off x="3517693" y="2511265"/>
            <a:ext cx="914095" cy="936523"/>
          </a:xfrm>
          <a:prstGeom prst="mathPlus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5B0C333-8D24-C7C1-327A-7776A1279EBD}"/>
              </a:ext>
            </a:extLst>
          </p:cNvPr>
          <p:cNvSpPr txBox="1"/>
          <p:nvPr/>
        </p:nvSpPr>
        <p:spPr>
          <a:xfrm>
            <a:off x="225468" y="112734"/>
            <a:ext cx="38951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1. Electron applicator + circle block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2917461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88A38D5-E774-6CA9-0C6C-E5D05282E402}"/>
              </a:ext>
            </a:extLst>
          </p:cNvPr>
          <p:cNvSpPr txBox="1"/>
          <p:nvPr/>
        </p:nvSpPr>
        <p:spPr>
          <a:xfrm>
            <a:off x="275572" y="187890"/>
            <a:ext cx="72917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2. Fixed-size </a:t>
            </a:r>
            <a:r>
              <a:rPr lang="en-US" altLang="ko-KR" sz="1800" kern="1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electron</a:t>
            </a:r>
            <a:r>
              <a:rPr lang="en-US" altLang="ko-KR" dirty="0"/>
              <a:t> cone applicator and </a:t>
            </a:r>
            <a:r>
              <a:rPr lang="en-US" altLang="ko-KR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removable stainless end tube</a:t>
            </a:r>
            <a:r>
              <a:rPr lang="en-US" altLang="ko-KR" dirty="0"/>
              <a:t> </a:t>
            </a:r>
            <a:endParaRPr lang="ko-KR" altLang="en-US" dirty="0"/>
          </a:p>
        </p:txBody>
      </p:sp>
      <p:pic>
        <p:nvPicPr>
          <p:cNvPr id="5" name="그림 4">
            <a:extLst>
              <a:ext uri="{FF2B5EF4-FFF2-40B4-BE49-F238E27FC236}">
                <a16:creationId xmlns:a16="http://schemas.microsoft.com/office/drawing/2014/main" id="{72BE8AAC-7E40-4A8C-306B-EDDF47CB415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63013" y="1536901"/>
            <a:ext cx="3615873" cy="3784198"/>
          </a:xfrm>
          <a:prstGeom prst="rect">
            <a:avLst/>
          </a:prstGeom>
        </p:spPr>
      </p:pic>
      <p:pic>
        <p:nvPicPr>
          <p:cNvPr id="6" name="그림 5">
            <a:extLst>
              <a:ext uri="{FF2B5EF4-FFF2-40B4-BE49-F238E27FC236}">
                <a16:creationId xmlns:a16="http://schemas.microsoft.com/office/drawing/2014/main" id="{AF04CFF0-112D-98A7-A00D-B5EEE3F6F9A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24138" y="2075016"/>
            <a:ext cx="3942689" cy="27079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008971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28</Words>
  <Application>Microsoft Office PowerPoint</Application>
  <PresentationFormat>와이드스크린</PresentationFormat>
  <Paragraphs>7</Paragraphs>
  <Slides>2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6" baseType="lpstr">
      <vt:lpstr>맑은 고딕</vt:lpstr>
      <vt:lpstr>Arial</vt:lpstr>
      <vt:lpstr>Times New Roman</vt:lpstr>
      <vt:lpstr>Office 테마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u chul han</dc:creator>
  <cp:lastModifiedBy>su chul han</cp:lastModifiedBy>
  <cp:revision>6</cp:revision>
  <dcterms:created xsi:type="dcterms:W3CDTF">2025-01-31T07:54:30Z</dcterms:created>
  <dcterms:modified xsi:type="dcterms:W3CDTF">2025-05-05T02:22:46Z</dcterms:modified>
</cp:coreProperties>
</file>